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85" d="100"/>
          <a:sy n="185" d="100"/>
        </p:scale>
        <p:origin x="168" y="172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5-Jan-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5-Jan-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4260706"/>
            <a:ext cx="1981200" cy="70763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658615" y="3879706"/>
            <a:ext cx="1112521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5079" y="1103749"/>
            <a:ext cx="7772400" cy="1111723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Optimization of the left ventricle ejection fraction estimate obtained during cardiac adenosine stress </a:t>
            </a:r>
            <a:r>
              <a:rPr lang="en-US" sz="16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82</a:t>
            </a:r>
            <a:r>
              <a:rPr lang="en-US" sz="16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ubidium-PET scanning: Impact of different reconstruction protocols</a:t>
            </a:r>
            <a:endParaRPr lang="en-US" sz="16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5079" y="2370869"/>
            <a:ext cx="7763359" cy="1365106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artin Lyngby Lassen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hD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Mads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Wissenberg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D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PhD, Christina Byrne, MD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PhD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Andreas Kjær, MD, PhD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MSc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, Philip Hasbak, MD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MSc</a:t>
            </a: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algn="l">
              <a:lnSpc>
                <a:spcPct val="107000"/>
              </a:lnSpc>
              <a:spcAft>
                <a:spcPts val="800"/>
              </a:spcAft>
            </a:pP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partment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of Clinical Physiology, Nuclear Medicine &amp; PET and Cluster for Molecular Imaging, Department of Biomedical Sciences,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igshospitalet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University of Copenhagen, </a:t>
            </a:r>
          </a:p>
          <a:p>
            <a:pPr algn="l">
              <a:lnSpc>
                <a:spcPct val="107000"/>
              </a:lnSpc>
              <a:spcAft>
                <a:spcPts val="800"/>
              </a:spcAft>
            </a:pP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epartment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of Cardiology, Copenhagen University Hospital, Gentofte, Denmark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 descr="A person wearing a white shirt&#10;&#10;Description automatically generated with low confidence">
            <a:extLst>
              <a:ext uri="{FF2B5EF4-FFF2-40B4-BE49-F238E27FC236}">
                <a16:creationId xmlns:a16="http://schemas.microsoft.com/office/drawing/2014/main" id="{F482D453-B801-4213-BB53-A362B61DA2D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8617" y="3861417"/>
            <a:ext cx="1112520" cy="156057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E7A369B-A790-452E-AD0E-B292E51673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6935" y="4348262"/>
            <a:ext cx="1924929" cy="5585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2400" dirty="0"/>
              <a:t>1- </a:t>
            </a:r>
            <a:r>
              <a:rPr lang="en-US" sz="2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ess Left Ventricular Ejection Fraction (LVEF) and LVEF reserve obtained using adenosine may be affected by its rapid metabolization</a:t>
            </a:r>
          </a:p>
          <a:p>
            <a:pPr marL="0" indent="0" algn="just">
              <a:buNone/>
            </a:pPr>
            <a:r>
              <a:rPr lang="en-US" altLang="en-US" dirty="0"/>
              <a:t>2-</a:t>
            </a:r>
            <a:r>
              <a:rPr lang="en-US" altLang="en-US" sz="2400" dirty="0"/>
              <a:t> </a:t>
            </a:r>
            <a:r>
              <a:rPr lang="en-US" sz="2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rrent reconstruction guidelines recommend the reconstruction starting 150s into the </a:t>
            </a:r>
            <a:r>
              <a:rPr lang="en-US" sz="2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82</a:t>
            </a:r>
            <a:r>
              <a:rPr lang="en-US" sz="2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b lasting until the end of acquisition (300-360s). For reference, our adenosine infusion protocol spans 0-210 into the </a:t>
            </a:r>
            <a:r>
              <a:rPr lang="en-US" sz="24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82</a:t>
            </a:r>
            <a:r>
              <a:rPr lang="en-US" sz="2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b infusion </a:t>
            </a:r>
          </a:p>
          <a:p>
            <a:pPr marL="0" indent="0" algn="just">
              <a:buNone/>
            </a:pPr>
            <a:r>
              <a:rPr lang="en-US" altLang="en-US" sz="2400" dirty="0"/>
              <a:t>3- </a:t>
            </a:r>
            <a:r>
              <a:rPr lang="en-US" sz="2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quiring data outside the maximum hyperemic response window may lower stress LVEF and LVEF reserve and introduce reduced test-retest reliability</a:t>
            </a: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type: Randomized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subjects: 25 (11F, 14M), inclusion criteria: &gt;18y, no medical history, exclusion: allergy to adenosine or asthma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Improvements in LVEF, LVEF reserve and test-retest reliability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econdary end point(s): Validation of new reconstruction protocols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tudy variables: Reconstruction window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nsert a key table or a key figure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f figure, insert lege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C3E0350-6AC5-471F-8B24-C0356833E14C}"/>
              </a:ext>
            </a:extLst>
          </p:cNvPr>
          <p:cNvSpPr txBox="1"/>
          <p:nvPr/>
        </p:nvSpPr>
        <p:spPr>
          <a:xfrm>
            <a:off x="544016" y="4969809"/>
            <a:ext cx="7620000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LVEF and LVEF reserve observed for the volunteers reported as the empirical measurements and the percentwise increase.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o differences were observed between the reconstruction protocols, except for the reconstructions protocols with markings where differences to one or more protocols are reported.</a:t>
            </a:r>
            <a:endParaRPr lang="en-US" sz="14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pic>
        <p:nvPicPr>
          <p:cNvPr id="3" name="Picture 2" descr="Chart, waterfall chart&#10;&#10;Description automatically generated">
            <a:extLst>
              <a:ext uri="{FF2B5EF4-FFF2-40B4-BE49-F238E27FC236}">
                <a16:creationId xmlns:a16="http://schemas.microsoft.com/office/drawing/2014/main" id="{B8F659B9-0834-400A-9821-4425BF210C4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0846" y="1600200"/>
            <a:ext cx="6329908" cy="34044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endParaRPr lang="en-US" sz="1400" b="1" dirty="0"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just">
              <a:buNone/>
            </a:pP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epeatability measures obtained for SV, LVEF and percent change in EF between rest and stress MPI. 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est-retest measures were obtained using the RMS method, with the unit being in % repeatability. Statistical differences in the test-retest measures were evaluated using Pitman-Morgan tests, with p&lt;0.05 indicating statistically significant differences. Significant differences were obtained for all repeatability measures, except the ones indicated with a marker. </a:t>
            </a:r>
            <a:endParaRPr lang="en-US" sz="1400" dirty="0">
              <a:effectLst/>
              <a:latin typeface="Arial" panose="020B0604020202020204" pitchFamily="34" charset="0"/>
              <a:ea typeface="Calibri" panose="020F0502020204030204" pitchFamily="34" charset="0"/>
            </a:endParaRPr>
          </a:p>
          <a:p>
            <a:pPr marL="0" indent="0" algn="ctr">
              <a:buNone/>
            </a:pPr>
            <a:endParaRPr lang="en-US" altLang="en-US" sz="2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F7A445B-6DF2-4F74-9EF6-22561ADA74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0752493"/>
              </p:ext>
            </p:extLst>
          </p:nvPr>
        </p:nvGraphicFramePr>
        <p:xfrm>
          <a:off x="990601" y="1524000"/>
          <a:ext cx="6477000" cy="335440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30346">
                  <a:extLst>
                    <a:ext uri="{9D8B030D-6E8A-4147-A177-3AD203B41FA5}">
                      <a16:colId xmlns:a16="http://schemas.microsoft.com/office/drawing/2014/main" val="4026650069"/>
                    </a:ext>
                  </a:extLst>
                </a:gridCol>
                <a:gridCol w="875945">
                  <a:extLst>
                    <a:ext uri="{9D8B030D-6E8A-4147-A177-3AD203B41FA5}">
                      <a16:colId xmlns:a16="http://schemas.microsoft.com/office/drawing/2014/main" val="3222734122"/>
                    </a:ext>
                  </a:extLst>
                </a:gridCol>
                <a:gridCol w="850978">
                  <a:extLst>
                    <a:ext uri="{9D8B030D-6E8A-4147-A177-3AD203B41FA5}">
                      <a16:colId xmlns:a16="http://schemas.microsoft.com/office/drawing/2014/main" val="662757492"/>
                    </a:ext>
                  </a:extLst>
                </a:gridCol>
                <a:gridCol w="850978">
                  <a:extLst>
                    <a:ext uri="{9D8B030D-6E8A-4147-A177-3AD203B41FA5}">
                      <a16:colId xmlns:a16="http://schemas.microsoft.com/office/drawing/2014/main" val="4154470778"/>
                    </a:ext>
                  </a:extLst>
                </a:gridCol>
                <a:gridCol w="851671">
                  <a:extLst>
                    <a:ext uri="{9D8B030D-6E8A-4147-A177-3AD203B41FA5}">
                      <a16:colId xmlns:a16="http://schemas.microsoft.com/office/drawing/2014/main" val="2710801629"/>
                    </a:ext>
                  </a:extLst>
                </a:gridCol>
                <a:gridCol w="908541">
                  <a:extLst>
                    <a:ext uri="{9D8B030D-6E8A-4147-A177-3AD203B41FA5}">
                      <a16:colId xmlns:a16="http://schemas.microsoft.com/office/drawing/2014/main" val="564978608"/>
                    </a:ext>
                  </a:extLst>
                </a:gridCol>
                <a:gridCol w="908541">
                  <a:extLst>
                    <a:ext uri="{9D8B030D-6E8A-4147-A177-3AD203B41FA5}">
                      <a16:colId xmlns:a16="http://schemas.microsoft.com/office/drawing/2014/main" val="475862169"/>
                    </a:ext>
                  </a:extLst>
                </a:gridCol>
              </a:tblGrid>
              <a:tr h="527951">
                <a:tc rowSpan="2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EDV (mL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SV (mL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LID4096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LVEF (%)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LID4096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LVEF reserve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20250115"/>
                  </a:ext>
                </a:extLst>
              </a:tr>
              <a:tr h="241794">
                <a:tc vMerge="1">
                  <a:txBody>
                    <a:bodyPr/>
                    <a:lstStyle/>
                    <a:p>
                      <a:endParaRPr lang="LID4096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Stress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Rest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Stress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Rest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Stress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Combined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92641721"/>
                  </a:ext>
                </a:extLst>
              </a:tr>
              <a:tr h="24179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Standard</a:t>
                      </a:r>
                      <a:r>
                        <a:rPr lang="en-US" sz="1200" baseline="-25000">
                          <a:effectLst/>
                        </a:rPr>
                        <a:t>recon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3.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7.8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5.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4.5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3.5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46.7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78405119"/>
                  </a:ext>
                </a:extLst>
              </a:tr>
              <a:tr h="24179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Short</a:t>
                      </a:r>
                      <a:r>
                        <a:rPr lang="en-US" sz="1200" baseline="-25000">
                          <a:effectLst/>
                        </a:rPr>
                        <a:t>fixed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l-GR" sz="1200">
                          <a:effectLst/>
                        </a:rPr>
                        <a:t>4.2</a:t>
                      </a:r>
                      <a:r>
                        <a:rPr lang="el-GR" sz="1200" baseline="30000">
                          <a:effectLst/>
                        </a:rPr>
                        <a:t>α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l-GR" sz="1200">
                          <a:effectLst/>
                        </a:rPr>
                        <a:t>7.2</a:t>
                      </a:r>
                      <a:r>
                        <a:rPr lang="el-GR" sz="1200" baseline="30000">
                          <a:effectLst/>
                        </a:rPr>
                        <a:t>α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l-GR" sz="1200">
                          <a:effectLst/>
                        </a:rPr>
                        <a:t>4.6</a:t>
                      </a:r>
                      <a:r>
                        <a:rPr lang="el-GR" sz="1200" baseline="30000">
                          <a:effectLst/>
                        </a:rPr>
                        <a:t>α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43.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92503568"/>
                  </a:ext>
                </a:extLst>
              </a:tr>
              <a:tr h="24179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Short</a:t>
                      </a:r>
                      <a:r>
                        <a:rPr lang="en-US" sz="1200" baseline="-25000">
                          <a:effectLst/>
                        </a:rPr>
                        <a:t>individual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3.6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5.8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2.7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33.9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22423596"/>
                  </a:ext>
                </a:extLst>
              </a:tr>
              <a:tr h="527951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Adeno</a:t>
                      </a:r>
                      <a:r>
                        <a:rPr lang="en-US" sz="1200" baseline="-25000">
                          <a:effectLst/>
                        </a:rPr>
                        <a:t>dynamicend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3.8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l-GR" sz="1200">
                          <a:effectLst/>
                        </a:rPr>
                        <a:t>7.8</a:t>
                      </a:r>
                      <a:r>
                        <a:rPr lang="el-GR" sz="1200" baseline="30000">
                          <a:effectLst/>
                        </a:rPr>
                        <a:t>β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4.7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l-GR" sz="1200">
                          <a:effectLst/>
                        </a:rPr>
                        <a:t>42.3</a:t>
                      </a:r>
                      <a:r>
                        <a:rPr lang="el-GR" sz="1200" baseline="30000">
                          <a:effectLst/>
                        </a:rPr>
                        <a:t>α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76646849"/>
                  </a:ext>
                </a:extLst>
              </a:tr>
              <a:tr h="24179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Adeno</a:t>
                      </a:r>
                      <a:r>
                        <a:rPr lang="en-US" sz="1200" baseline="-25000">
                          <a:effectLst/>
                        </a:rPr>
                        <a:t>individual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l-GR" sz="1200">
                          <a:effectLst/>
                        </a:rPr>
                        <a:t>3.5</a:t>
                      </a:r>
                      <a:r>
                        <a:rPr lang="el-GR" sz="1200" baseline="30000">
                          <a:effectLst/>
                        </a:rPr>
                        <a:t>β</a:t>
                      </a:r>
                      <a:endParaRPr lang="el-GR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6.6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5.8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53.2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77636959"/>
                  </a:ext>
                </a:extLst>
              </a:tr>
              <a:tr h="474396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Last</a:t>
                      </a:r>
                      <a:r>
                        <a:rPr lang="en-US" sz="1200" baseline="-25000">
                          <a:effectLst/>
                        </a:rPr>
                        <a:t>60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4.6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A</a:t>
                      </a:r>
                    </a:p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9.1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NA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</a:rPr>
                        <a:t>7.3</a:t>
                      </a:r>
                      <a:endParaRPr lang="en-US" sz="12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</a:rPr>
                        <a:t>94.2</a:t>
                      </a:r>
                      <a:endParaRPr lang="en-US" sz="12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471052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2800" dirty="0"/>
              <a:t>1- Metabolism of adenosine during the guideline recommend window reduces LVEF and LVEF reserve assessments</a:t>
            </a:r>
          </a:p>
          <a:p>
            <a:pPr marL="0" indent="0" algn="just">
              <a:buNone/>
            </a:pPr>
            <a:r>
              <a:rPr lang="en-US" altLang="en-US" sz="2800" dirty="0"/>
              <a:t>2- </a:t>
            </a:r>
            <a:r>
              <a:rPr lang="en-US" sz="2800" b="0" i="0" dirty="0">
                <a:solidFill>
                  <a:srgbClr val="000000"/>
                </a:solidFill>
                <a:effectLst/>
              </a:rPr>
              <a:t>Shortening (Truncating) the reconstruction window to containing only data obtained during adenosine infusion (hyperemic response) increases the LVEF and LVEF reserve, and improves the test-retest repeatability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</TotalTime>
  <Words>591</Words>
  <Application>Microsoft Office PowerPoint</Application>
  <PresentationFormat>On-screen Show (4:3)</PresentationFormat>
  <Paragraphs>10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Optimization of the left ventricle ejection fraction estimate obtained during cardiac adenosine stress 82Rubidium-PET scanning: Impact of different reconstruction protocols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artin Lassen</cp:lastModifiedBy>
  <cp:revision>101</cp:revision>
  <dcterms:created xsi:type="dcterms:W3CDTF">2011-04-18T21:44:13Z</dcterms:created>
  <dcterms:modified xsi:type="dcterms:W3CDTF">2022-01-25T10:39:35Z</dcterms:modified>
</cp:coreProperties>
</file>